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3" d="100"/>
          <a:sy n="83" d="100"/>
        </p:scale>
        <p:origin x="-76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515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846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5961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06857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965085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82084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21257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7922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263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166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209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3EA1C-3196-6742-804C-332C9D855F4C}" type="datetimeFigureOut">
              <a:rPr lang="fr-FR" smtClean="0"/>
              <a:t>15/11/19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CEFAED-A621-6245-9AFB-8B20F0C7B4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0741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7494" y="933270"/>
            <a:ext cx="4182582" cy="3691004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1196246" y="4870756"/>
            <a:ext cx="700765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00" b="1" dirty="0" smtClean="0">
                <a:latin typeface="Palatino Linp"/>
                <a:cs typeface="Palatino Linp"/>
              </a:rPr>
              <a:t>Supplementary Figure S1</a:t>
            </a:r>
            <a:r>
              <a:rPr lang="en-GB" sz="1600" dirty="0" smtClean="0">
                <a:latin typeface="Palatino Linp"/>
                <a:cs typeface="Palatino Linp"/>
              </a:rPr>
              <a:t>: </a:t>
            </a:r>
            <a:r>
              <a:rPr lang="en-GB" sz="1600" dirty="0">
                <a:latin typeface="Palatino Linp"/>
                <a:cs typeface="Palatino Linp"/>
              </a:rPr>
              <a:t>AFM analysis of </a:t>
            </a:r>
            <a:r>
              <a:rPr lang="en-GB" sz="1600" dirty="0" err="1">
                <a:latin typeface="Palatino Linp"/>
                <a:cs typeface="Palatino Linp"/>
              </a:rPr>
              <a:t>Hfq</a:t>
            </a:r>
            <a:r>
              <a:rPr lang="en-GB" sz="1600" dirty="0">
                <a:latin typeface="Palatino Linp"/>
                <a:cs typeface="Palatino Linp"/>
              </a:rPr>
              <a:t>-CTR </a:t>
            </a:r>
            <a:r>
              <a:rPr lang="en-GB" sz="1600" dirty="0" smtClean="0">
                <a:latin typeface="Palatino Linp"/>
                <a:cs typeface="Palatino Linp"/>
              </a:rPr>
              <a:t>fibrils in the absence of DNA. Left: height </a:t>
            </a:r>
            <a:r>
              <a:rPr lang="en-GB" sz="1600" dirty="0">
                <a:latin typeface="Palatino Linp"/>
                <a:cs typeface="Palatino Linp"/>
              </a:rPr>
              <a:t>image of the </a:t>
            </a:r>
            <a:r>
              <a:rPr lang="en-GB" sz="1600" dirty="0" smtClean="0">
                <a:latin typeface="Palatino Linp"/>
                <a:cs typeface="Palatino Linp"/>
              </a:rPr>
              <a:t>fibrils. </a:t>
            </a:r>
            <a:r>
              <a:rPr lang="en-GB" sz="1600" dirty="0">
                <a:latin typeface="Palatino Linp"/>
                <a:cs typeface="Palatino Linp"/>
              </a:rPr>
              <a:t>Right, </a:t>
            </a:r>
            <a:r>
              <a:rPr lang="en-US" sz="1600" dirty="0">
                <a:latin typeface="Palatino Linp"/>
                <a:cs typeface="Palatino Linp"/>
              </a:rPr>
              <a:t>representation of the orientation of the </a:t>
            </a:r>
            <a:r>
              <a:rPr lang="en-US" sz="1600" dirty="0" smtClean="0">
                <a:latin typeface="Palatino Linp"/>
                <a:cs typeface="Palatino Linp"/>
              </a:rPr>
              <a:t>fibrils. </a:t>
            </a:r>
            <a:r>
              <a:rPr lang="en-GB" sz="1600" dirty="0">
                <a:latin typeface="Palatino Linp"/>
                <a:cs typeface="Palatino Linp"/>
              </a:rPr>
              <a:t>A</a:t>
            </a:r>
            <a:r>
              <a:rPr lang="en-GB" sz="1600" dirty="0" smtClean="0">
                <a:latin typeface="Palatino Linp"/>
                <a:cs typeface="Palatino Linp"/>
              </a:rPr>
              <a:t>s shown, the </a:t>
            </a:r>
            <a:r>
              <a:rPr lang="en-GB" sz="1600" dirty="0">
                <a:latin typeface="Palatino Linp"/>
                <a:cs typeface="Palatino Linp"/>
              </a:rPr>
              <a:t>fibrils </a:t>
            </a:r>
            <a:r>
              <a:rPr lang="en-GB" sz="1600" dirty="0" smtClean="0">
                <a:latin typeface="Palatino Linp"/>
                <a:cs typeface="Palatino Linp"/>
              </a:rPr>
              <a:t>have no </a:t>
            </a:r>
            <a:r>
              <a:rPr lang="en-GB" sz="1600" dirty="0">
                <a:latin typeface="Palatino Linp"/>
                <a:cs typeface="Palatino Linp"/>
              </a:rPr>
              <a:t>preferred </a:t>
            </a:r>
            <a:r>
              <a:rPr lang="en-GB" sz="1600" dirty="0" smtClean="0">
                <a:latin typeface="Palatino Linp"/>
                <a:cs typeface="Palatino Linp"/>
              </a:rPr>
              <a:t>orientation</a:t>
            </a:r>
            <a:r>
              <a:rPr lang="en-GB" sz="1600" dirty="0">
                <a:latin typeface="Palatino Linp"/>
                <a:cs typeface="Palatino Linp"/>
              </a:rPr>
              <a:t> </a:t>
            </a:r>
            <a:r>
              <a:rPr lang="en-GB" sz="1600" dirty="0" smtClean="0">
                <a:latin typeface="Palatino Linp"/>
                <a:cs typeface="Palatino Linp"/>
              </a:rPr>
              <a:t>in the absence of DNA. </a:t>
            </a:r>
            <a:endParaRPr lang="en-GB" sz="1600" dirty="0">
              <a:latin typeface="Palatino Linp"/>
              <a:cs typeface="Palatino Linp"/>
            </a:endParaRP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76562" y="1169706"/>
            <a:ext cx="3961154" cy="3123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407690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0</Words>
  <Application>Microsoft Macintosh PowerPoint</Application>
  <PresentationFormat>Présentation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CEA UP7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Veronique</dc:creator>
  <cp:lastModifiedBy>Veronique</cp:lastModifiedBy>
  <cp:revision>3</cp:revision>
  <dcterms:created xsi:type="dcterms:W3CDTF">2019-11-15T11:28:41Z</dcterms:created>
  <dcterms:modified xsi:type="dcterms:W3CDTF">2019-11-15T12:17:25Z</dcterms:modified>
</cp:coreProperties>
</file>